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2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6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6810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5764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036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482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5794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9339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1383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03125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0160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6674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0413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C0B25-D895-435F-871E-FC22472B030E}" type="datetimeFigureOut">
              <a:rPr lang="zh-CN" altLang="en-US" smtClean="0"/>
              <a:t>2023/7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D8D9E-7E8C-4034-886A-AC1F5CCF9B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6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A83980B2-04A3-9DE7-2DA0-3328BDC045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175" y="955651"/>
            <a:ext cx="4393245" cy="329493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458230E-9A19-3297-6282-CF92CFE369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8252" y="955651"/>
            <a:ext cx="4393245" cy="3294934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B29B6EBB-6713-2D68-93D6-58D38F3A5A3C}"/>
              </a:ext>
            </a:extLst>
          </p:cNvPr>
          <p:cNvSpPr txBox="1"/>
          <p:nvPr/>
        </p:nvSpPr>
        <p:spPr>
          <a:xfrm>
            <a:off x="207180" y="1032709"/>
            <a:ext cx="263989" cy="32056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627205D6-2F0C-BF83-391A-3DC43DE5E4D6}"/>
              </a:ext>
            </a:extLst>
          </p:cNvPr>
          <p:cNvSpPr txBox="1"/>
          <p:nvPr/>
        </p:nvSpPr>
        <p:spPr>
          <a:xfrm>
            <a:off x="4475749" y="1032709"/>
            <a:ext cx="30809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1A2C2DDE-7B12-341A-8237-3ACE08B19F01}"/>
              </a:ext>
            </a:extLst>
          </p:cNvPr>
          <p:cNvSpPr txBox="1"/>
          <p:nvPr/>
        </p:nvSpPr>
        <p:spPr>
          <a:xfrm>
            <a:off x="1413423" y="5050323"/>
            <a:ext cx="66379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 predicted protein structures of GmPHT2;1 and GmPHT2;2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7280031A-E219-36A9-E63F-D17A3A59AECB}"/>
              </a:ext>
            </a:extLst>
          </p:cNvPr>
          <p:cNvSpPr txBox="1"/>
          <p:nvPr/>
        </p:nvSpPr>
        <p:spPr>
          <a:xfrm>
            <a:off x="1413423" y="5419655"/>
            <a:ext cx="655640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predicted protein structures of GmPHT2;1; </a:t>
            </a:r>
          </a:p>
          <a:p>
            <a:pPr>
              <a:lnSpc>
                <a:spcPct val="150000"/>
              </a:lnSpc>
            </a:pP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, predicted protein structures of GmPHT2;2;</a:t>
            </a:r>
          </a:p>
        </p:txBody>
      </p:sp>
    </p:spTree>
    <p:extLst>
      <p:ext uri="{BB962C8B-B14F-4D97-AF65-F5344CB8AC3E}">
        <p14:creationId xmlns:p14="http://schemas.microsoft.com/office/powerpoint/2010/main" val="1957263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1</TotalTime>
  <Words>2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魏 晓双</dc:creator>
  <cp:lastModifiedBy>MDPI</cp:lastModifiedBy>
  <cp:revision>49</cp:revision>
  <dcterms:created xsi:type="dcterms:W3CDTF">2022-11-28T09:19:33Z</dcterms:created>
  <dcterms:modified xsi:type="dcterms:W3CDTF">2023-07-05T02:48:27Z</dcterms:modified>
</cp:coreProperties>
</file>